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885D6B-9749-46DA-B29C-4541D6B3FD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28299D-26CF-4143-BF93-901D6F2274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58738A-9B44-4144-BF11-928FAE183F8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5C1582-5DC8-4528-9303-D3F722662A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3FC2B4-0390-4752-9A5B-C03833D3B7C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A8F5C3-F7FC-4F4D-AB6E-5CF7C5D46F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BD2A78-C3EA-48D7-A62F-EAF5527C97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9347D5-6E0B-48C5-83DC-71163D06E7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911546-4C15-487F-AE02-E5119164C0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555533-6BF9-456C-A16F-934A6284D5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F97CEA-E2F8-4F0E-88A3-35EDAF3161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678B33-C02F-405C-91B6-AB3669B974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A46FD1-6EA4-412A-80D2-EB15E9000B8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80880" y="1523880"/>
          <a:ext cx="6096240" cy="2109960"/>
        </p:xfrm>
        <a:graphic>
          <a:graphicData uri="http://schemas.openxmlformats.org/drawingml/2006/table">
            <a:tbl>
              <a:tblPr/>
              <a:tblGrid>
                <a:gridCol w="2362320"/>
                <a:gridCol w="1436760"/>
                <a:gridCol w="1458720"/>
                <a:gridCol w="838440"/>
              </a:tblGrid>
              <a:tr h="28908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hGFP (n = 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hCTSK (n = 8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-value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62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one Volume Fractio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6 ± 0.0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5 ± 0.00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0.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6504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abecular Number (1/mm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886 ± 0.14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589 ± 0.17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0.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504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abecular Thickness (mm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9 ± 0.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46 ± 0.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0.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492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rabecular Spacing (mm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54 ± 0.018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86 ± 0.01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0.0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5400"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one Mineral Density (mg/cc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46.6 ± 17.4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75.4 ± 9.50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4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9T17:32:24Z</dcterms:created>
  <dc:creator>April Chan</dc:creator>
  <dc:description/>
  <dc:language>en-US</dc:language>
  <cp:lastModifiedBy>April Chan</cp:lastModifiedBy>
  <dcterms:modified xsi:type="dcterms:W3CDTF">2009-10-30T17:20:46Z</dcterms:modified>
  <cp:revision>2</cp:revision>
  <dc:subject/>
  <dc:title>Slide 1</dc:title>
</cp:coreProperties>
</file>